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0" r:id="rId2"/>
  </p:sldIdLst>
  <p:sldSz cx="12192000" cy="6858000"/>
  <p:notesSz cx="6797675" cy="9928225"/>
  <p:custDataLst>
    <p:tags r:id="rId4"/>
  </p:custDataLst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FAC6852-675B-094E-9E35-A68436CB67B0}" v="108" dt="2025-01-27T19:17:06.41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50" autoAdjust="0"/>
    <p:restoredTop sz="95812" autoAdjust="0"/>
  </p:normalViewPr>
  <p:slideViewPr>
    <p:cSldViewPr snapToGrid="0">
      <p:cViewPr varScale="1">
        <p:scale>
          <a:sx n="95" d="100"/>
          <a:sy n="95" d="100"/>
        </p:scale>
        <p:origin x="31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>
      <p:cViewPr>
        <p:scale>
          <a:sx n="66" d="100"/>
          <a:sy n="66" d="100"/>
        </p:scale>
        <p:origin x="0" y="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54BCC748-50F2-4A98-8610-7D8CF1E207C8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57AD1F1E-07BF-403C-AC87-F7EB9DB1F89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24046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8D047D-08AA-96FF-461D-B63FE9E5C8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B0CBF80D-4C95-50B5-E1FD-DD5844106DB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7D1F7E3-D527-9F25-B015-FACB7CE184A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defRPr/>
            </a:pPr>
            <a:endParaRPr lang="en-US" sz="1200" b="1" u="none" kern="1200">
              <a:solidFill>
                <a:schemeClr val="tx1"/>
              </a:solidFill>
              <a:effectLst/>
              <a:latin typeface="+mn-lt"/>
              <a:ea typeface="Times New Roman"/>
              <a:cs typeface="Arial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A7AFE0-3E40-0C43-C521-94D0A0E3FDE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AA0D8C-4F76-44AD-A4F1-C0E4F03ED73D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834104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3005CD-4662-4CA0-2900-A874C9DDB0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C81BAC8-5DB8-BA48-0F97-4F2FE55418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FA43ED-EC2B-76C5-57D7-D61D212C6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E85657-781C-7679-4C31-7B4F78411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9F5FE-2AA1-8C81-F9DE-983E7AEC1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60205968"/>
      </p:ext>
    </p:extLst>
  </p:cSld>
  <p:clrMapOvr>
    <a:masterClrMapping/>
  </p:clrMapOvr>
  <p:transition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B9C33-739A-1055-6B4D-29A9C97F4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D46D9A-BCD6-9135-2F5C-98BFD1F96C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A663D8-C1A2-7B45-2C29-5E3BF7EE7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0EE243-66B6-516C-C194-8266E99CA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40FF16-9D5E-1504-EF66-DBB636F86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9741333"/>
      </p:ext>
    </p:extLst>
  </p:cSld>
  <p:clrMapOvr>
    <a:masterClrMapping/>
  </p:clrMapOvr>
  <p:transition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662D237-3515-1AF4-88F0-091921C5F7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EF8866-CE63-F0DE-808E-061876DCA9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65C34A-D872-6145-CF30-EBD18568B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517D6-1BBA-6760-0013-88C55836C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141A72-A21B-AC24-E7CF-C0ACA9C6B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37709027"/>
      </p:ext>
    </p:extLst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5F8399-03DA-295F-B811-338764CBE4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37FB81-06AB-DC10-A619-5E36330F28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C04375-F0AC-8120-CA02-2A1433D5C7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88B69E-6489-6340-65F2-230F1BC33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9D8576-4507-7966-C701-0E916F82A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90297629"/>
      </p:ext>
    </p:extLst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A5CB8A-2C1C-0B71-6813-A33CB48DA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F8733A-ED49-C23D-75A3-65BDBD5D5C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A7A80E-28C0-A7B1-D176-4160EB77F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9AD698-11B1-05A7-A071-4BAC2C2B1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4CCB93-1FD8-29F1-74DE-4B6142C37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4461872"/>
      </p:ext>
    </p:extLst>
  </p:cSld>
  <p:clrMapOvr>
    <a:masterClrMapping/>
  </p:clrMapOvr>
  <p:transition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62408-792D-6749-D69F-14B991AF77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FC7553-0439-B984-AD41-24CB73C020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00B02B-4263-6B79-76F0-83489B5438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8B06AE-2933-E621-6070-7FC591647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3EB95A-8A56-87AB-68F8-7DD65525B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9102CC-378F-D74D-50C8-EAEAFEFDC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600400"/>
      </p:ext>
    </p:extLst>
  </p:cSld>
  <p:clrMapOvr>
    <a:masterClrMapping/>
  </p:clrMapOvr>
  <p:transition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61146-8BC5-992C-82AA-01DA87C69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D9D6B5-B3AF-6516-4A18-873EBADCE5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3310DA-0AC7-4E32-2DF9-A741F2D3B2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C19A6AE-CE96-736A-CEC1-EE9AAD99D7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2608D16-32D4-38F5-6312-E3177FB439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98F380-6096-5AC9-3257-BA058EB6E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62A457-C96C-DF24-A74F-2905479B9E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22F214-6D22-2D55-E9EF-2785D0B484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81221327"/>
      </p:ext>
    </p:extLst>
  </p:cSld>
  <p:clrMapOvr>
    <a:masterClrMapping/>
  </p:clrMapOvr>
  <p:transition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9A287-44BC-0BF7-3A15-48DFB4CD42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7E0495-BEA9-0385-2C2F-8F556D662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B868CA0-9CE2-2A75-57DD-300A04EEE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FDBB0C-3D7B-3DAC-6931-76031F351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88255049"/>
      </p:ext>
    </p:extLst>
  </p:cSld>
  <p:clrMapOvr>
    <a:masterClrMapping/>
  </p:clrMapOvr>
  <p:transition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4756FB-572A-8952-A996-A9DC093D1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8ACEE4-FC0A-4DBD-E2DF-5F13E23C6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25E8C1E-1B48-C3CC-0502-C1146EBE6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64269070"/>
      </p:ext>
    </p:extLst>
  </p:cSld>
  <p:clrMapOvr>
    <a:masterClrMapping/>
  </p:clrMapOvr>
  <p:transition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3F9F8E-62A1-C827-FE77-5E788E302D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43C65A-5D32-9E90-61D2-5D0747B621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6BB4D9-4F0B-3913-3B35-40D73DAB8E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2CA003-107F-7E13-8922-14EC24E5D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8C4841-ADCA-FA2F-0557-EEA8F1FEA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413DDF-A438-AEA2-0716-647598051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34452839"/>
      </p:ext>
    </p:extLst>
  </p:cSld>
  <p:clrMapOvr>
    <a:masterClrMapping/>
  </p:clrMapOvr>
  <p:transition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6E9517-48FF-9F38-EE65-6264165972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9E046D8-C895-DF47-99B4-16424D979F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56370D-EC9C-97DF-7EAC-0115CF30DE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77A73-AABF-F275-4B39-BF75CB6CA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1F46D9-C9C6-729A-73CC-C065662F4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278F85-5606-0A2E-C771-01D7B1E9F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06785897"/>
      </p:ext>
    </p:extLst>
  </p:cSld>
  <p:clrMapOvr>
    <a:masterClrMapping/>
  </p:clrMapOvr>
  <p:transition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CE54F64-A90D-0590-03B0-B175F900EE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97CF66-F72C-6C5C-979B-D6972A7BAD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102F41-D88F-6A80-0A16-E5D4F98E68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82D93-9750-4F44-A21F-EAF69E5790A5}" type="datetimeFigureOut">
              <a:rPr lang="he-IL" smtClean="0"/>
              <a:t>כ"ג/שבט/תשפ"ה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02E26-4474-616B-6742-435F16EC6F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290F84-3B3D-4495-17C4-28C07DC63A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2D6145-1F5E-4B0D-9F24-BA275BB34F8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06609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DC8FE39-583F-46A1-9093-6A0A52B7A6B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>
            <a:extLst>
              <a:ext uri="{FF2B5EF4-FFF2-40B4-BE49-F238E27FC236}">
                <a16:creationId xmlns:a16="http://schemas.microsoft.com/office/drawing/2014/main" id="{2A5E557E-20B0-CC06-5AA6-C6820D9D16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245" y="638008"/>
            <a:ext cx="10515600" cy="257531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lIns="91440" tIns="45720" rIns="91440" bIns="45720" numCol="1" rtlCol="0" anchor="ctr" anchorCtr="0" compatLnSpc="1">
            <a:prstTxWarp prst="textNoShape">
              <a:avLst/>
            </a:prstTxWarp>
            <a:normAutofit/>
          </a:bodyPr>
          <a:lstStyle/>
          <a:p>
            <a:pPr fontAlgn="base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altLang="he-IL" sz="1100" b="1" dirty="0">
                <a:latin typeface="+mj-lt"/>
                <a:ea typeface="+mj-ea"/>
                <a:cs typeface="+mj-cs"/>
              </a:rPr>
              <a:t>Supplementary </a:t>
            </a:r>
            <a:r>
              <a:rPr lang="en-US" altLang="he-IL" sz="11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Table </a:t>
            </a:r>
            <a:r>
              <a:rPr lang="en-US" altLang="he-IL" sz="1100" b="1" dirty="0">
                <a:latin typeface="+mj-lt"/>
                <a:ea typeface="+mj-ea"/>
                <a:cs typeface="+mj-cs"/>
              </a:rPr>
              <a:t>1</a:t>
            </a:r>
            <a:r>
              <a:rPr lang="en-US" altLang="he-IL" sz="11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. Comparison of additional signs and symptoms of brucellosis and rickettsiosis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52C5E44-7524-3BA5-C45B-F4388E051B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3685166"/>
              </p:ext>
            </p:extLst>
          </p:nvPr>
        </p:nvGraphicFramePr>
        <p:xfrm>
          <a:off x="780153" y="1041011"/>
          <a:ext cx="7544523" cy="1573848"/>
        </p:xfrm>
        <a:graphic>
          <a:graphicData uri="http://schemas.openxmlformats.org/drawingml/2006/table">
            <a:tbl>
              <a:tblPr firstRow="1" firstCol="1" bandRow="1"/>
              <a:tblGrid>
                <a:gridCol w="29262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35767">
                  <a:extLst>
                    <a:ext uri="{9D8B030D-6E8A-4147-A177-3AD203B41FA5}">
                      <a16:colId xmlns:a16="http://schemas.microsoft.com/office/drawing/2014/main" val="3282333248"/>
                    </a:ext>
                  </a:extLst>
                </a:gridCol>
                <a:gridCol w="1835767">
                  <a:extLst>
                    <a:ext uri="{9D8B030D-6E8A-4147-A177-3AD203B41FA5}">
                      <a16:colId xmlns:a16="http://schemas.microsoft.com/office/drawing/2014/main" val="2909304079"/>
                    </a:ext>
                  </a:extLst>
                </a:gridCol>
                <a:gridCol w="946759">
                  <a:extLst>
                    <a:ext uri="{9D8B030D-6E8A-4147-A177-3AD203B41FA5}">
                      <a16:colId xmlns:a16="http://schemas.microsoft.com/office/drawing/2014/main" val="2332083464"/>
                    </a:ext>
                  </a:extLst>
                </a:gridCol>
              </a:tblGrid>
              <a:tr h="357512"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1" u="non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 </a:t>
                      </a:r>
                      <a:endParaRPr lang="en-US" sz="1050" b="1" u="none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33035" marR="33035" marT="0" marB="0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1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Brucellosis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1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N=440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1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Rickettsiosis</a:t>
                      </a: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1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N=</a:t>
                      </a:r>
                      <a:r>
                        <a:rPr lang="he-IL" sz="1050" b="1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335</a:t>
                      </a:r>
                      <a:endParaRPr lang="en-US" sz="1050" b="1" i="0" u="none" kern="1200" baseline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/>
                        <a:cs typeface="David"/>
                      </a:endParaRP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1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P value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1" u="non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Arial"/>
                        </a:rPr>
                        <a:t>Diarrhea </a:t>
                      </a:r>
                    </a:p>
                  </a:txBody>
                  <a:tcPr marL="33035" marR="3303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25</a:t>
                      </a:r>
                      <a:r>
                        <a:rPr lang="he-IL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 </a:t>
                      </a: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 (5.7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39 (11.6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1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0.004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844447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1" u="non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Arial"/>
                        </a:rPr>
                        <a:t>Abdominal pain</a:t>
                      </a:r>
                    </a:p>
                  </a:txBody>
                  <a:tcPr marL="33035" marR="3303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33 (7.5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73 (21.8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1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&lt;0.001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468503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1" u="non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Arial"/>
                        </a:rPr>
                        <a:t>Vomiting</a:t>
                      </a:r>
                    </a:p>
                  </a:txBody>
                  <a:tcPr marL="33035" marR="3303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54 (12.3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129 (38.5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1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&lt;0.001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298427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1" u="non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Arial"/>
                        </a:rPr>
                        <a:t>Seizures</a:t>
                      </a:r>
                      <a:r>
                        <a:rPr lang="en-US" sz="1050" b="1" u="none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Arial"/>
                        </a:rPr>
                        <a:t> / loss of consciousness </a:t>
                      </a:r>
                      <a:endParaRPr lang="en-US" sz="1050" b="1" u="none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33035" marR="3303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8 (1.8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21 (6.3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0.002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957474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u="non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+mn-cs"/>
                        </a:rPr>
                        <a:t>Nuchal rigidity</a:t>
                      </a:r>
                    </a:p>
                  </a:txBody>
                  <a:tcPr marL="33035" marR="3303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1 (0.2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10 (3.0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0.001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94301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1" u="non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Arial"/>
                        </a:rPr>
                        <a:t>Upper respiratory</a:t>
                      </a:r>
                      <a:r>
                        <a:rPr lang="en-US" sz="1050" b="1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Arial"/>
                        </a:rPr>
                        <a:t> tract infection (URI)</a:t>
                      </a:r>
                      <a:endParaRPr lang="en-US" sz="1050" b="1" u="non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  <a:cs typeface="Arial"/>
                      </a:endParaRPr>
                    </a:p>
                  </a:txBody>
                  <a:tcPr marL="33035" marR="3303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57 (13.0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85 (25.4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1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&lt;0.001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467521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u="non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Arial"/>
                        </a:rPr>
                        <a:t>Lower respiratory </a:t>
                      </a:r>
                      <a:r>
                        <a:rPr lang="en-US" sz="1050" b="1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/>
                          <a:cs typeface="+mn-cs"/>
                        </a:rPr>
                        <a:t>tract infection (LRI)</a:t>
                      </a:r>
                      <a:endParaRPr lang="en-US" sz="1050" b="1" u="non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Times New Roman"/>
                        <a:cs typeface="+mn-cs"/>
                      </a:endParaRPr>
                    </a:p>
                  </a:txBody>
                  <a:tcPr marL="33035" marR="3303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11 (2.5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18 (5.4%)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ct val="0"/>
                        </a:spcAft>
                      </a:pPr>
                      <a:r>
                        <a:rPr lang="en-US" sz="1050" b="0" i="0" u="non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/>
                          <a:cs typeface="David"/>
                        </a:rPr>
                        <a:t>0.05</a:t>
                      </a:r>
                    </a:p>
                  </a:txBody>
                  <a:tcPr marL="33035" marR="3303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546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1020400"/>
      </p:ext>
    </p:extLst>
  </p:cSld>
  <p:clrMapOvr>
    <a:masterClrMapping/>
  </p:clrMapOvr>
  <p:transition/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42000"/>
  <p:tag name="AS_OS" val="Microsoft Windows NT 6.2.9200.0"/>
  <p:tag name="AS_RELEASE_DATE" val="2022.10.14"/>
  <p:tag name="AS_TITLE" val="Aspose.Slides for .NET 4.0"/>
  <p:tag name="AS_VERSION" val="22.1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Calibri Light" panose="020F0302020204030204"/>
        <a:cs typeface="Times New Roman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Calibri" panose="020F0502020204030204"/>
        <a:cs typeface="Arial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Calibri Light" panose="020F0302020204030204"/>
        <a:cs typeface="Arial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Calibri" panose="020F0502020204030204"/>
        <a:cs typeface="Arial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7</TotalTime>
  <Words>117</Words>
  <Application>Microsoft Office PowerPoint</Application>
  <PresentationFormat>Widescreen</PresentationFormat>
  <Paragraphs>3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שלום בן שימול</dc:creator>
  <cp:lastModifiedBy>MDPI</cp:lastModifiedBy>
  <cp:revision>9</cp:revision>
  <cp:lastPrinted>2024-11-12T13:08:29Z</cp:lastPrinted>
  <dcterms:created xsi:type="dcterms:W3CDTF">2022-07-08T07:12:55Z</dcterms:created>
  <dcterms:modified xsi:type="dcterms:W3CDTF">2025-02-21T14:03:15Z</dcterms:modified>
</cp:coreProperties>
</file>